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47474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1348" autoAdjust="0"/>
    <p:restoredTop sz="89452" autoAdjust="0"/>
  </p:normalViewPr>
  <p:slideViewPr>
    <p:cSldViewPr snapToGrid="0">
      <p:cViewPr varScale="1">
        <p:scale>
          <a:sx n="109" d="100"/>
          <a:sy n="109" d="100"/>
        </p:scale>
        <p:origin x="216" y="2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520127F-E7C3-499D-87D0-FB73F73DE973}" type="datetimeFigureOut">
              <a:rPr lang="en-US" smtClean="0"/>
              <a:t>2/18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7294EE7-32C3-4A76-8BAA-0F2EFB63D68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78075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002AA2-643D-396E-9897-37C82F313E33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A9E1D41-D2BC-58BA-9552-052D909D247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034468-C373-0A43-9265-6F8C1B00AB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16B628-2923-9B51-14BA-6DEA6BD3B4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8C64F0-1363-F03D-CBAB-818066C5CA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55578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B78FD-C4C3-28FE-E46B-78476FD269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4B73FEB-EE35-AEB8-6D45-8F130690AFE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BFEA45-A444-4626-0891-E74ECF429C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E128966-8990-E71C-3593-36941573C7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3348F2B-BE74-F041-8A76-7A0E763370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0264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E1FE38DD-2BF9-5829-B68A-7CC440475F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4624E60-D797-800A-77DB-D9807ECCB94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59B996-3A4D-B2AC-3064-92F2731120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8887AA3-7C6E-3C97-ABEA-45BB8464765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7DB0BC9-E2FF-C1B2-BB04-8C19F543B9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4278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05ACD5-8F36-3716-24A9-D54619B0CF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A581EB4-D1F8-1058-FC68-0F0E722B3A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CF9399-6487-51B8-34C7-7F0E05886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46A8CC8-5E39-10EF-D6F1-09FA6C873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596D50-0841-FC4E-3B1D-D55644A3739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1825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BBAA356-40EF-EA35-359D-E32B9FF174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BBB6F3-408B-77CB-EF30-8DCF4AE30D5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E6F1D-8B90-16B0-E6B3-9A4ED102B2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9C4A7-C8EC-E372-4C3D-DDF6FCA663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5854AE6-DBB7-9C65-F12D-9A57990CC6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48829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FDD54F-CEE3-536E-3B37-20ED3B0BCD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A5AB7BF-3839-E576-CAC5-F5D9BC958CA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5AF6FA-FE95-D6BD-DF62-AB12A95101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657D9D-359E-8F69-394B-86D0C87DE4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9ABD2B5-1FC5-B07D-E4A0-84611E81AA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BCD874A-5497-961F-41D7-7663A6B861A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921328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53C7E-E3F0-0B45-EA3E-1CD11DABE0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34BEB3-2FA7-66C4-EBC3-4F2C23B91E5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75E56D9-4B77-3B15-F4CB-155318B3824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BACC024-FEAE-CA44-D686-C063CBF412F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71FAC7-4E9D-7F6A-A1DA-F14277AB64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F5F4EF4-97A4-E80E-E4BB-B72EDC077D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670EA3A-014B-546D-BAE3-D5B34C5707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11DA68-99C5-BF6E-00C0-CD343979AE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08760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8F4C40-0ED6-5CB5-8F20-705F6D2D42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DEE02FC-6A96-4DCA-16A8-5DEB619E8E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555BA05-66F1-919B-2032-324CCACF95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FF13DDD-4F58-E5EA-2462-0BE72E4AD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80747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11181DE-CC5E-414E-6778-C5923DBB62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AB9BF87-E610-89BC-5EFA-C9351F2E14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75B81EF-13B2-041D-3E16-EC54DF7F4B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3529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D8A4330-DF86-604D-A4BA-E3AADFC52D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DAD60F-AD60-49D8-02F3-4A99E87594F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CDF7D71-6BA7-768A-0BA9-E05350857E6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59F720B-1E30-2A62-9360-788E0B98D7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3A0F762-8EB7-3CFE-99D8-7F8F490A9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9656EAF-17D3-D0C7-D098-6E3C11FBD6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382751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3C9FE45-8DAC-E665-9AD2-969DCEBDB3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2A70F62-E3A8-ED31-3A2F-361909DFF69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F2B8889-C7D0-E4BD-6246-53D00C70FD9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66F377-A668-0E56-4D49-768B4C27E5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0B495D8-C24E-6905-DCF2-8D98AE85F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66D1483-02C0-5771-1DCE-C7900E2506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8277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95F7B11-ACF7-F065-A8C9-497B07D0E58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C04D26F-3D44-ED5E-5930-6C46B358D4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7CAAC75-30B3-8555-5B11-3EBAC0BF3F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36049-A40B-4CDF-9A61-196349A1BB3D}" type="datetimeFigureOut">
              <a:rPr lang="en-US" smtClean="0"/>
              <a:t>2/18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9AD1939-41DC-616A-23E0-70D1E46F687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BD8A46-AAA6-9F36-1323-CBCBB22CC8F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E3EA02-547D-404F-B29C-546213EE49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2708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close-up of a chart&#10;&#10;AI-generated content may be incorrect.">
            <a:extLst>
              <a:ext uri="{FF2B5EF4-FFF2-40B4-BE49-F238E27FC236}">
                <a16:creationId xmlns:a16="http://schemas.microsoft.com/office/drawing/2014/main" id="{4006698F-1100-589A-1582-DC98E9E9804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2813" y="0"/>
            <a:ext cx="2372050" cy="6858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A1B1BAA4-F7C4-8E71-4323-4D2234D993A4}"/>
              </a:ext>
            </a:extLst>
          </p:cNvPr>
          <p:cNvSpPr txBox="1"/>
          <p:nvPr/>
        </p:nvSpPr>
        <p:spPr>
          <a:xfrm>
            <a:off x="3590144" y="156520"/>
            <a:ext cx="7852556" cy="16312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Full Ingenuity Pathway Analysis (IPA) network of enriched pathways derived from DMP-associated genes from the comparison C2D5 v.s. C1D1. Orange indicates activated pathways and blue indicates suppressed pathways (|z| &gt; 2). Gray represents weak or no effect, with no predicted direction of change, and white indicates insufficient data to predict pathway activity.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499118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899</TotalTime>
  <Words>68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bbasi Farid, Elnaz</dc:creator>
  <cp:lastModifiedBy>Nephew, Kenneth P</cp:lastModifiedBy>
  <cp:revision>102</cp:revision>
  <cp:lastPrinted>2025-11-20T14:34:39Z</cp:lastPrinted>
  <dcterms:created xsi:type="dcterms:W3CDTF">2025-04-15T14:41:30Z</dcterms:created>
  <dcterms:modified xsi:type="dcterms:W3CDTF">2026-02-18T21:08:38Z</dcterms:modified>
</cp:coreProperties>
</file>